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78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840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342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029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7062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7770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993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9237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5807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0701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5981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9237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6BA02-708F-46DE-9B3A-FAA5F7E10260}" type="datetimeFigureOut">
              <a:rPr lang="fr-FR" smtClean="0"/>
              <a:t>15/03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6CEEF-C64F-4E71-AC56-EB5AEA48EE8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5195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3781" y="43350"/>
            <a:ext cx="9767455" cy="6202034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429789" y="5243287"/>
            <a:ext cx="921050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. S1</a:t>
            </a:r>
            <a:r>
              <a:rPr lang="en-US" dirty="0"/>
              <a:t> Detection of transgene sequences in </a:t>
            </a:r>
            <a:r>
              <a:rPr lang="en-US" i="1" dirty="0" err="1"/>
              <a:t>Bd</a:t>
            </a:r>
            <a:r>
              <a:rPr lang="en-US" i="1" dirty="0"/>
              <a:t> GUS</a:t>
            </a:r>
            <a:r>
              <a:rPr lang="en-US" dirty="0"/>
              <a:t> </a:t>
            </a:r>
            <a:r>
              <a:rPr lang="en-US" dirty="0" err="1"/>
              <a:t>transformants</a:t>
            </a:r>
            <a:r>
              <a:rPr lang="en-US" dirty="0"/>
              <a:t>.  Agarose gel (1%) for </a:t>
            </a:r>
            <a:r>
              <a:rPr lang="en-US" i="1" dirty="0" err="1"/>
              <a:t>HptII</a:t>
            </a:r>
            <a:r>
              <a:rPr lang="en-US" dirty="0"/>
              <a:t> PCR amplicon analysis. Lanes 1 and 17: 1kb Plus DNA Ladder (Invitrogen); lanes 2 to 13:  bulked T1 progeny of plants listed in Table 1; lanes 14 and 15: negative controls; lane 16: positive control.</a:t>
            </a:r>
            <a:endParaRPr lang="fr-FR" dirty="0"/>
          </a:p>
        </p:txBody>
      </p:sp>
      <p:sp>
        <p:nvSpPr>
          <p:cNvPr id="17" name="ZoneTexte 16"/>
          <p:cNvSpPr txBox="1"/>
          <p:nvPr/>
        </p:nvSpPr>
        <p:spPr>
          <a:xfrm>
            <a:off x="4911392" y="2171408"/>
            <a:ext cx="1286640" cy="646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dirty="0"/>
          </a:p>
        </p:txBody>
      </p:sp>
      <p:grpSp>
        <p:nvGrpSpPr>
          <p:cNvPr id="26" name="Groupe 25"/>
          <p:cNvGrpSpPr/>
          <p:nvPr/>
        </p:nvGrpSpPr>
        <p:grpSpPr>
          <a:xfrm>
            <a:off x="2201088" y="144981"/>
            <a:ext cx="7662111" cy="1924387"/>
            <a:chOff x="2201088" y="144981"/>
            <a:chExt cx="7662111" cy="1924387"/>
          </a:xfrm>
        </p:grpSpPr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369380" y="635923"/>
              <a:ext cx="493819" cy="1109568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323807" y="831773"/>
              <a:ext cx="493819" cy="1237595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835660" y="831773"/>
              <a:ext cx="493819" cy="1060796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 rot="16200000">
              <a:off x="1803863" y="881149"/>
              <a:ext cx="11637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1</a:t>
              </a:r>
              <a:endParaRPr lang="fr-FR" dirty="0"/>
            </a:p>
          </p:txBody>
        </p:sp>
        <p:sp>
          <p:nvSpPr>
            <p:cNvPr id="14" name="ZoneTexte 13"/>
            <p:cNvSpPr txBox="1"/>
            <p:nvPr/>
          </p:nvSpPr>
          <p:spPr>
            <a:xfrm rot="16200000">
              <a:off x="2252601" y="785552"/>
              <a:ext cx="135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2</a:t>
              </a:r>
              <a:endParaRPr lang="fr-FR" dirty="0"/>
            </a:p>
          </p:txBody>
        </p:sp>
        <p:sp>
          <p:nvSpPr>
            <p:cNvPr id="15" name="ZoneTexte 14"/>
            <p:cNvSpPr txBox="1"/>
            <p:nvPr/>
          </p:nvSpPr>
          <p:spPr>
            <a:xfrm rot="16200000">
              <a:off x="2946565" y="906087"/>
              <a:ext cx="11139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3</a:t>
              </a:r>
              <a:endParaRPr lang="fr-FR" dirty="0"/>
            </a:p>
          </p:txBody>
        </p:sp>
        <p:sp>
          <p:nvSpPr>
            <p:cNvPr id="16" name="ZoneTexte 15"/>
            <p:cNvSpPr txBox="1"/>
            <p:nvPr/>
          </p:nvSpPr>
          <p:spPr>
            <a:xfrm rot="16200000">
              <a:off x="3473637" y="974959"/>
              <a:ext cx="10474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5</a:t>
              </a:r>
              <a:endParaRPr lang="fr-FR" dirty="0"/>
            </a:p>
          </p:txBody>
        </p:sp>
        <p:sp>
          <p:nvSpPr>
            <p:cNvPr id="18" name="ZoneTexte 17"/>
            <p:cNvSpPr txBox="1"/>
            <p:nvPr/>
          </p:nvSpPr>
          <p:spPr>
            <a:xfrm rot="16200000">
              <a:off x="3946024" y="931024"/>
              <a:ext cx="11637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6</a:t>
              </a:r>
              <a:endParaRPr lang="fr-FR" dirty="0"/>
            </a:p>
          </p:txBody>
        </p:sp>
        <p:sp>
          <p:nvSpPr>
            <p:cNvPr id="19" name="ZoneTexte 18"/>
            <p:cNvSpPr txBox="1"/>
            <p:nvPr/>
          </p:nvSpPr>
          <p:spPr>
            <a:xfrm rot="16200000">
              <a:off x="4368494" y="832509"/>
              <a:ext cx="13323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7</a:t>
              </a:r>
              <a:endParaRPr lang="fr-FR" dirty="0"/>
            </a:p>
          </p:txBody>
        </p:sp>
        <p:sp>
          <p:nvSpPr>
            <p:cNvPr id="20" name="ZoneTexte 19"/>
            <p:cNvSpPr txBox="1"/>
            <p:nvPr/>
          </p:nvSpPr>
          <p:spPr>
            <a:xfrm rot="16200000">
              <a:off x="4862907" y="833102"/>
              <a:ext cx="13311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8</a:t>
              </a:r>
              <a:endParaRPr lang="fr-FR" dirty="0"/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5474078" y="955927"/>
              <a:ext cx="11468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9</a:t>
              </a:r>
              <a:endParaRPr lang="fr-FR" dirty="0"/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5818120" y="855716"/>
              <a:ext cx="14953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10</a:t>
              </a:r>
              <a:endParaRPr lang="fr-FR" dirty="0"/>
            </a:p>
          </p:txBody>
        </p:sp>
        <p:sp>
          <p:nvSpPr>
            <p:cNvPr id="23" name="ZoneTexte 22"/>
            <p:cNvSpPr txBox="1"/>
            <p:nvPr/>
          </p:nvSpPr>
          <p:spPr>
            <a:xfrm rot="16200000">
              <a:off x="6222822" y="785552"/>
              <a:ext cx="1650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11</a:t>
              </a:r>
              <a:endParaRPr lang="fr-FR" dirty="0"/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6955058" y="1010396"/>
              <a:ext cx="12557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12</a:t>
              </a:r>
              <a:endParaRPr lang="fr-FR" dirty="0"/>
            </a:p>
          </p:txBody>
        </p:sp>
        <p:sp>
          <p:nvSpPr>
            <p:cNvPr id="25" name="ZoneTexte 24"/>
            <p:cNvSpPr txBox="1"/>
            <p:nvPr/>
          </p:nvSpPr>
          <p:spPr>
            <a:xfrm rot="16200000">
              <a:off x="7299719" y="832509"/>
              <a:ext cx="15712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GUS#13</a:t>
              </a:r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9006219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955949" y="496332"/>
            <a:ext cx="10571380" cy="5919729"/>
            <a:chOff x="955949" y="496332"/>
            <a:chExt cx="10571380" cy="5919729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5949" y="496332"/>
              <a:ext cx="10571380" cy="5919729"/>
            </a:xfrm>
            <a:prstGeom prst="rect">
              <a:avLst/>
            </a:prstGeom>
          </p:spPr>
        </p:pic>
        <p:grpSp>
          <p:nvGrpSpPr>
            <p:cNvPr id="4" name="Groupe 3"/>
            <p:cNvGrpSpPr/>
            <p:nvPr/>
          </p:nvGrpSpPr>
          <p:grpSpPr>
            <a:xfrm>
              <a:off x="2388045" y="626942"/>
              <a:ext cx="8020611" cy="1219374"/>
              <a:chOff x="2404748" y="577065"/>
              <a:chExt cx="8020611" cy="1219374"/>
            </a:xfrm>
          </p:grpSpPr>
          <p:sp>
            <p:nvSpPr>
              <p:cNvPr id="2" name="ZoneTexte 1"/>
              <p:cNvSpPr txBox="1"/>
              <p:nvPr/>
            </p:nvSpPr>
            <p:spPr>
              <a:xfrm rot="16200000">
                <a:off x="2111432" y="922712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101</a:t>
                </a:r>
                <a:endParaRPr lang="fr-FR" dirty="0"/>
              </a:p>
            </p:txBody>
          </p:sp>
          <p:sp>
            <p:nvSpPr>
              <p:cNvPr id="7" name="ZoneTexte 6"/>
              <p:cNvSpPr txBox="1"/>
              <p:nvPr/>
            </p:nvSpPr>
            <p:spPr>
              <a:xfrm rot="16200000">
                <a:off x="2636509" y="920337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1</a:t>
                </a:r>
                <a:endParaRPr lang="fr-FR" dirty="0"/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 rot="16200000">
                <a:off x="3119181" y="922712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2</a:t>
                </a:r>
                <a:endParaRPr lang="fr-FR" dirty="0"/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 rot="16200000">
                <a:off x="3608769" y="930719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3</a:t>
                </a:r>
                <a:endParaRPr lang="fr-FR" dirty="0"/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 rot="16200000">
                <a:off x="4098357" y="922711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4</a:t>
                </a:r>
                <a:endParaRPr lang="fr-FR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 rot="16200000">
                <a:off x="4616518" y="930719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5</a:t>
                </a:r>
                <a:endParaRPr lang="fr-FR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 rot="16200000">
                <a:off x="5106106" y="922710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6</a:t>
                </a:r>
                <a:endParaRPr lang="fr-FR" dirty="0"/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 rot="16200000">
                <a:off x="5546609" y="930719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7</a:t>
                </a:r>
                <a:endParaRPr lang="fr-FR" dirty="0"/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 rot="16200000">
                <a:off x="6046731" y="990338"/>
                <a:ext cx="8367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301</a:t>
                </a:r>
                <a:endParaRPr lang="fr-FR" dirty="0"/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 rot="16200000">
                <a:off x="6456171" y="942915"/>
                <a:ext cx="87828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303</a:t>
                </a:r>
                <a:endParaRPr lang="fr-FR" dirty="0"/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 rot="16200000">
                <a:off x="6957507" y="1006599"/>
                <a:ext cx="8042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305</a:t>
                </a:r>
                <a:endParaRPr lang="fr-FR" dirty="0"/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 rot="16200000">
                <a:off x="7376802" y="936306"/>
                <a:ext cx="94479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306</a:t>
                </a:r>
                <a:endParaRPr lang="fr-FR" dirty="0"/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 rot="16200000">
                <a:off x="7919885" y="990337"/>
                <a:ext cx="80420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102</a:t>
                </a:r>
                <a:endParaRPr lang="fr-FR" dirty="0"/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 rot="16200000">
                <a:off x="8365381" y="952109"/>
                <a:ext cx="88066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208</a:t>
                </a:r>
                <a:endParaRPr lang="fr-FR" dirty="0"/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 rot="16200000">
                <a:off x="8801687" y="981752"/>
                <a:ext cx="955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smtClean="0"/>
                  <a:t>T- water</a:t>
                </a:r>
                <a:endParaRPr lang="fr-FR" dirty="0"/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 rot="16200000">
                <a:off x="9187961" y="1027064"/>
                <a:ext cx="11694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T- Bd 21-3</a:t>
                </a: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 rot="16200000">
                <a:off x="9712755" y="920337"/>
                <a:ext cx="10558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 err="1"/>
                  <a:t>Vector</a:t>
                </a:r>
                <a:endParaRPr lang="fr-FR" dirty="0"/>
              </a:p>
            </p:txBody>
          </p:sp>
        </p:grpSp>
      </p:grpSp>
      <p:sp>
        <p:nvSpPr>
          <p:cNvPr id="24" name="Rectangle 23"/>
          <p:cNvSpPr/>
          <p:nvPr/>
        </p:nvSpPr>
        <p:spPr>
          <a:xfrm>
            <a:off x="1073880" y="621852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a</a:t>
            </a:r>
            <a:r>
              <a:rPr lang="en-US" dirty="0"/>
              <a:t>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9960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823369" y="348249"/>
            <a:ext cx="10193406" cy="6356040"/>
            <a:chOff x="1020464" y="375958"/>
            <a:chExt cx="10193406" cy="6356040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2"/>
            <a:srcRect l="5786" t="23039" r="46945" b="25555"/>
            <a:stretch/>
          </p:blipFill>
          <p:spPr>
            <a:xfrm>
              <a:off x="1020464" y="496332"/>
              <a:ext cx="10193406" cy="6235666"/>
            </a:xfrm>
            <a:prstGeom prst="rect">
              <a:avLst/>
            </a:prstGeom>
          </p:spPr>
        </p:pic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70519" y="375958"/>
              <a:ext cx="7886645" cy="1268078"/>
            </a:xfrm>
            <a:prstGeom prst="rect">
              <a:avLst/>
            </a:prstGeom>
          </p:spPr>
        </p:pic>
      </p:grpSp>
      <p:sp>
        <p:nvSpPr>
          <p:cNvPr id="6" name="ZoneTexte 5"/>
          <p:cNvSpPr txBox="1"/>
          <p:nvPr/>
        </p:nvSpPr>
        <p:spPr>
          <a:xfrm>
            <a:off x="1466503" y="5057636"/>
            <a:ext cx="955027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. S2</a:t>
            </a:r>
            <a:r>
              <a:rPr lang="en-US" dirty="0"/>
              <a:t> Detection of transgene sequences in T0 </a:t>
            </a:r>
            <a:r>
              <a:rPr lang="en-US" i="1" dirty="0" err="1"/>
              <a:t>Bd</a:t>
            </a:r>
            <a:r>
              <a:rPr lang="en-US" i="1" dirty="0"/>
              <a:t> NR</a:t>
            </a:r>
            <a:r>
              <a:rPr lang="en-US" dirty="0"/>
              <a:t> mutant candidate </a:t>
            </a:r>
            <a:r>
              <a:rPr lang="en-US" dirty="0" err="1"/>
              <a:t>regenerants</a:t>
            </a:r>
            <a:r>
              <a:rPr lang="en-US" dirty="0"/>
              <a:t>.  </a:t>
            </a:r>
            <a:r>
              <a:rPr lang="en-US" b="1" dirty="0"/>
              <a:t>a</a:t>
            </a:r>
            <a:r>
              <a:rPr lang="en-US" dirty="0"/>
              <a:t> Agarose gel (1%) for </a:t>
            </a:r>
            <a:r>
              <a:rPr lang="en-US" i="1" dirty="0" err="1"/>
              <a:t>HptII</a:t>
            </a:r>
            <a:r>
              <a:rPr lang="en-US" dirty="0"/>
              <a:t> PCR amplicon analysis. Lanes 1 and 19: 1kb Plus DNA Ladder (Invitrogen); lanes 2 to 15: CRISPR/Cas9-induced </a:t>
            </a:r>
            <a:r>
              <a:rPr lang="en-US" i="1" dirty="0"/>
              <a:t>NR</a:t>
            </a:r>
            <a:r>
              <a:rPr lang="en-US" dirty="0"/>
              <a:t> mutant candidates represented in Fig. 2; lanes 16 and 17: negative controls; lane 18: positive control. </a:t>
            </a:r>
            <a:r>
              <a:rPr lang="en-US" dirty="0" smtClean="0"/>
              <a:t> </a:t>
            </a:r>
            <a:r>
              <a:rPr lang="en-US" b="1" dirty="0" smtClean="0"/>
              <a:t>b</a:t>
            </a:r>
            <a:r>
              <a:rPr lang="en-US" dirty="0" smtClean="0"/>
              <a:t> Agarose </a:t>
            </a:r>
            <a:r>
              <a:rPr lang="en-US" dirty="0"/>
              <a:t>gel (1%) for </a:t>
            </a:r>
            <a:r>
              <a:rPr lang="en-US" i="1" dirty="0"/>
              <a:t>Cas9</a:t>
            </a:r>
            <a:r>
              <a:rPr lang="en-US" dirty="0"/>
              <a:t> PCR </a:t>
            </a:r>
            <a:r>
              <a:rPr lang="en-US" dirty="0" err="1"/>
              <a:t>amplificon</a:t>
            </a:r>
            <a:r>
              <a:rPr lang="en-US" dirty="0"/>
              <a:t> analysis. Same configuration as above.</a:t>
            </a:r>
            <a:endParaRPr lang="fr-FR" dirty="0"/>
          </a:p>
        </p:txBody>
      </p:sp>
      <p:sp>
        <p:nvSpPr>
          <p:cNvPr id="4" name="Rectangle 3"/>
          <p:cNvSpPr/>
          <p:nvPr/>
        </p:nvSpPr>
        <p:spPr>
          <a:xfrm>
            <a:off x="1455722" y="612956"/>
            <a:ext cx="360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b</a:t>
            </a:r>
            <a:r>
              <a:rPr lang="en-US" dirty="0"/>
              <a:t>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0895649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1</TotalTime>
  <Words>183</Words>
  <Application>Microsoft Office PowerPoint</Application>
  <PresentationFormat>Widescreen</PresentationFormat>
  <Paragraphs>3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</vt:vector>
  </TitlesOfParts>
  <Company>INR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mille Soulhat</dc:creator>
  <cp:lastModifiedBy>Sangeetha Nanda Gopal</cp:lastModifiedBy>
  <cp:revision>34</cp:revision>
  <dcterms:created xsi:type="dcterms:W3CDTF">2022-10-24T15:07:40Z</dcterms:created>
  <dcterms:modified xsi:type="dcterms:W3CDTF">2023-03-15T10:02:04Z</dcterms:modified>
</cp:coreProperties>
</file>